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347" r:id="rId2"/>
    <p:sldId id="344" r:id="rId3"/>
    <p:sldId id="345" r:id="rId4"/>
    <p:sldId id="346" r:id="rId5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>
        <p:scale>
          <a:sx n="34" d="100"/>
          <a:sy n="34" d="100"/>
        </p:scale>
        <p:origin x="788" y="7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FD28F1D-AB27-44A6-8C6D-E4001B8ACBD7}" type="datetimeFigureOut">
              <a:rPr kumimoji="1" lang="ja-JP" altLang="en-US" smtClean="0"/>
              <a:t>2021/8/2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6FA2DD8-AA09-4D08-A8B7-ADCFEA570A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29259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979353E-F7D9-4254-A818-5637D987F8E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7A7EC051-F172-4A40-81AB-A11FDEBA88B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C490E49-6AE1-471A-A22C-DEAAD2DD88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6716B-1CA5-4249-870B-F9A205850B9D}" type="datetimeFigureOut">
              <a:rPr kumimoji="1" lang="ja-JP" altLang="en-US" smtClean="0"/>
              <a:t>2021/8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D38E01F-6441-4956-A8FE-8A02E5041A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8DEBD94-FC09-4AA5-A2D9-79E8656447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C2B6A-023C-4287-8299-053094140D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77939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CE52D3D-7683-46C7-84FE-730168F477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06C5CAD-0CD5-4A86-A54B-26A63FCDB56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3D86AA3-1132-4FE3-BE04-5A0F57B492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6716B-1CA5-4249-870B-F9A205850B9D}" type="datetimeFigureOut">
              <a:rPr kumimoji="1" lang="ja-JP" altLang="en-US" smtClean="0"/>
              <a:t>2021/8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9C62D1D-CFD9-4173-8675-9A3E742D25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69E12BA-3CEC-48EB-8395-1E859CF0FA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C2B6A-023C-4287-8299-053094140D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47507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D639C80F-ED9C-4381-A9EE-74613AF61E7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31507D9-97AA-4D75-9C34-9B8E6BF436F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74390B7-7C8B-4D2E-ABDE-E60016C131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6716B-1CA5-4249-870B-F9A205850B9D}" type="datetimeFigureOut">
              <a:rPr kumimoji="1" lang="ja-JP" altLang="en-US" smtClean="0"/>
              <a:t>2021/8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FC04B06-74E3-44E8-B38E-BC10ECD30D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3E59D4F-A190-48F6-AD53-6AD6A4EB20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C2B6A-023C-4287-8299-053094140D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0596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121676A-CC36-4AE6-B03F-E3CF8811B3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984A044-4FE6-48E1-8529-7A400CB03FE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DC3D011-8378-455D-B52E-59AFA990B4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6716B-1CA5-4249-870B-F9A205850B9D}" type="datetimeFigureOut">
              <a:rPr kumimoji="1" lang="ja-JP" altLang="en-US" smtClean="0"/>
              <a:t>2021/8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EC9023D-82A8-4467-B87F-12ADC3C89B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DE0912E-3F67-4AEE-9B82-04A8F39BB9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C2B6A-023C-4287-8299-053094140D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3197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185B4C9-E302-473C-AB09-D0BD4EC2FF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46716CD-170C-424B-BD72-F18E74ACA8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2C00F35-8BB4-49B6-B557-7234297320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6716B-1CA5-4249-870B-F9A205850B9D}" type="datetimeFigureOut">
              <a:rPr kumimoji="1" lang="ja-JP" altLang="en-US" smtClean="0"/>
              <a:t>2021/8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FFA9604-011B-4D10-A581-DE460E1173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5BB2798-9DEF-48F2-AF01-F8737DA880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C2B6A-023C-4287-8299-053094140D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03262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2C5FEEE-81E2-47BC-B34A-CC0C3E6FAB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C008152-4D60-4A18-BC7A-0B3740818F4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7B8DBA4-BBEC-4F8D-B693-72B254B9C13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E768A74-5A00-4AC1-8E51-F57CFE6599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6716B-1CA5-4249-870B-F9A205850B9D}" type="datetimeFigureOut">
              <a:rPr kumimoji="1" lang="ja-JP" altLang="en-US" smtClean="0"/>
              <a:t>2021/8/2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1E7B8E7-8BA9-4118-901D-901220E9F9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3687AB7-434F-4B89-B9B2-D17AD18F45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C2B6A-023C-4287-8299-053094140D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29254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3C7D9FB-4A24-4C3D-A031-DDAEC6BF4B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4E58333-6787-4EB0-AB3C-5E27B13F95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E5B9EF2-9AAE-43CD-9FF3-B32AD66A48E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1F2E4E33-DA88-4E4D-83DB-3EB3EFB12FB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883B9748-88FC-4C75-893B-E62E32B9F05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2D12379E-6E57-406D-B358-081D043C6B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6716B-1CA5-4249-870B-F9A205850B9D}" type="datetimeFigureOut">
              <a:rPr kumimoji="1" lang="ja-JP" altLang="en-US" smtClean="0"/>
              <a:t>2021/8/28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9304E510-733C-4891-8D7E-A82634947B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3E511162-4584-4CB4-9FB0-DD6AAC958D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C2B6A-023C-4287-8299-053094140D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77204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0EE8103-2060-465A-801D-096B26DD63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B64A5963-AB57-40F1-8F1F-4C1E1F36BB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6716B-1CA5-4249-870B-F9A205850B9D}" type="datetimeFigureOut">
              <a:rPr kumimoji="1" lang="ja-JP" altLang="en-US" smtClean="0"/>
              <a:t>2021/8/28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BC333CFF-A6BF-489F-B861-E20A932F74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30A72B37-17E8-4E77-B9DD-C81F8F8253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C2B6A-023C-4287-8299-053094140D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50787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234172FC-8975-4FDE-AC27-F8507C4BAA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6716B-1CA5-4249-870B-F9A205850B9D}" type="datetimeFigureOut">
              <a:rPr kumimoji="1" lang="ja-JP" altLang="en-US" smtClean="0"/>
              <a:t>2021/8/28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9AE1EE96-B8E0-4798-9153-4FED5F7B70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937781C4-6119-42D8-AA40-7A2C97EC52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C2B6A-023C-4287-8299-053094140D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1778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AF09355-D75F-48F3-B501-FE57AFBAFA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E78ECE9-DE5C-479E-A8C2-CE8E64491C3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371D009-9937-4320-83CD-485EBC2A11C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62E0702-407D-41D2-A81C-DA01BE524B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6716B-1CA5-4249-870B-F9A205850B9D}" type="datetimeFigureOut">
              <a:rPr kumimoji="1" lang="ja-JP" altLang="en-US" smtClean="0"/>
              <a:t>2021/8/2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D9206E8-8373-4755-8851-5C7932D357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E55CB59-3051-4801-9848-A7267D93C2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C2B6A-023C-4287-8299-053094140D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34719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433A2DF-F452-44AB-A3C6-18F29534EB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C8FFEB5B-7687-40B9-BE28-02804EB9527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8BD1D28-147F-4BF9-B394-FD7AB831E1E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7A403E1-C6A2-4AF2-8D2B-44104664F4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6716B-1CA5-4249-870B-F9A205850B9D}" type="datetimeFigureOut">
              <a:rPr kumimoji="1" lang="ja-JP" altLang="en-US" smtClean="0"/>
              <a:t>2021/8/2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CD8652E-04C2-4B88-B16A-3C7EF75568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E506CBB-70F4-4E0D-94FD-BA90960659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C2B6A-023C-4287-8299-053094140D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64503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79EA469-948D-4377-A142-F02ED7D754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F6DB626-9926-44B7-BF60-2B6FCECCF1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43A9F01-A650-4B62-9405-780874E2ECA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C6716B-1CA5-4249-870B-F9A205850B9D}" type="datetimeFigureOut">
              <a:rPr kumimoji="1" lang="ja-JP" altLang="en-US" smtClean="0"/>
              <a:t>2021/8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9E4C711-98A2-478D-B305-12F9847AEF1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C8583B6-4A58-4724-9F37-D3AD56840A2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5C2B6A-023C-4287-8299-053094140D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02977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e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3">
            <a:extLst>
              <a:ext uri="{FF2B5EF4-FFF2-40B4-BE49-F238E27FC236}">
                <a16:creationId xmlns:a16="http://schemas.microsoft.com/office/drawing/2014/main" id="{8B923E9C-4D2F-4359-B6DC-705B8BB3901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60883320"/>
              </p:ext>
            </p:extLst>
          </p:nvPr>
        </p:nvGraphicFramePr>
        <p:xfrm>
          <a:off x="2686093" y="2870350"/>
          <a:ext cx="7324662" cy="18542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619822">
                  <a:extLst>
                    <a:ext uri="{9D8B030D-6E8A-4147-A177-3AD203B41FA5}">
                      <a16:colId xmlns:a16="http://schemas.microsoft.com/office/drawing/2014/main" val="4157713322"/>
                    </a:ext>
                  </a:extLst>
                </a:gridCol>
                <a:gridCol w="3003232">
                  <a:extLst>
                    <a:ext uri="{9D8B030D-6E8A-4147-A177-3AD203B41FA5}">
                      <a16:colId xmlns:a16="http://schemas.microsoft.com/office/drawing/2014/main" val="903812490"/>
                    </a:ext>
                  </a:extLst>
                </a:gridCol>
                <a:gridCol w="2701608">
                  <a:extLst>
                    <a:ext uri="{9D8B030D-6E8A-4147-A177-3AD203B41FA5}">
                      <a16:colId xmlns:a16="http://schemas.microsoft.com/office/drawing/2014/main" val="2805924311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indent="349250" algn="ctr">
                        <a:lnSpc>
                          <a:spcPts val="1300"/>
                        </a:lnSpc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XH </a:t>
                      </a:r>
                      <a:endParaRPr lang="ja-JP" sz="1800" b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indent="69850" algn="ctr">
                        <a:lnSpc>
                          <a:spcPts val="1300"/>
                        </a:lnSpc>
                      </a:pPr>
                      <a:r>
                        <a:rPr lang="en-US" sz="1800" b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Te</a:t>
                      </a:r>
                      <a:r>
                        <a:rPr lang="en-US" sz="1800" b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-H bond-formation energy </a:t>
                      </a:r>
                      <a:endParaRPr lang="ja-JP" sz="1800" b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indent="69850" algn="ctr">
                        <a:lnSpc>
                          <a:spcPts val="1300"/>
                        </a:lnSpc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Deviation from </a:t>
                      </a:r>
                      <a:r>
                        <a:rPr lang="en-US" sz="1800" b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PhTeH</a:t>
                      </a:r>
                      <a:r>
                        <a:rPr lang="en-US" sz="1800" b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 </a:t>
                      </a:r>
                      <a:endParaRPr lang="ja-JP" sz="1800" b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8844238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indent="139700" algn="r">
                        <a:lnSpc>
                          <a:spcPts val="1300"/>
                        </a:lnSpc>
                      </a:pPr>
                      <a:r>
                        <a:rPr lang="en-US" sz="1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p-Cl-</a:t>
                      </a:r>
                      <a:r>
                        <a:rPr lang="en-US" sz="18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PhTeH</a:t>
                      </a:r>
                      <a:r>
                        <a:rPr lang="en-US" sz="1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 </a:t>
                      </a:r>
                      <a:endParaRPr lang="ja-JP" sz="18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indent="69850" algn="ctr">
                        <a:lnSpc>
                          <a:spcPts val="1300"/>
                        </a:lnSpc>
                      </a:pPr>
                      <a:r>
                        <a:rPr lang="en-US" sz="1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-7.618 eV (-175.67 kcal/mol) </a:t>
                      </a:r>
                      <a:endParaRPr lang="ja-JP" sz="18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sz="1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+66 </a:t>
                      </a:r>
                      <a:r>
                        <a:rPr lang="en-US" sz="18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meV</a:t>
                      </a:r>
                      <a:r>
                        <a:rPr lang="en-US" sz="1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 (+1.53 kcal/mol) </a:t>
                      </a:r>
                      <a:endParaRPr lang="ja-JP" sz="18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7098119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indent="419100" algn="r">
                        <a:lnSpc>
                          <a:spcPts val="1300"/>
                        </a:lnSpc>
                      </a:pPr>
                      <a:r>
                        <a:rPr lang="en-US" sz="18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PhTeH</a:t>
                      </a:r>
                      <a:r>
                        <a:rPr lang="en-US" sz="1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 </a:t>
                      </a:r>
                      <a:endParaRPr lang="ja-JP" sz="18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indent="69850" algn="ctr">
                        <a:lnSpc>
                          <a:spcPts val="1300"/>
                        </a:lnSpc>
                      </a:pPr>
                      <a:r>
                        <a:rPr lang="en-US" sz="1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-7.684 eV (-177.20 kcal/mol) </a:t>
                      </a:r>
                      <a:endParaRPr lang="ja-JP" sz="18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indent="419100" algn="ctr">
                        <a:lnSpc>
                          <a:spcPts val="1300"/>
                        </a:lnSpc>
                      </a:pPr>
                      <a:r>
                        <a:rPr lang="en-US" altLang="ja-JP" sz="1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0</a:t>
                      </a:r>
                      <a:endParaRPr lang="ja-JP" sz="18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411199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r">
                        <a:lnSpc>
                          <a:spcPts val="1300"/>
                        </a:lnSpc>
                      </a:pPr>
                      <a:r>
                        <a:rPr lang="en-US" sz="1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p-</a:t>
                      </a:r>
                      <a:r>
                        <a:rPr lang="en-US" sz="18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MeO</a:t>
                      </a:r>
                      <a:r>
                        <a:rPr lang="en-US" sz="1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8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PhTeH</a:t>
                      </a:r>
                      <a:r>
                        <a:rPr lang="en-US" sz="1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 </a:t>
                      </a:r>
                      <a:endParaRPr lang="ja-JP" sz="18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indent="69850" algn="ctr">
                        <a:lnSpc>
                          <a:spcPts val="1300"/>
                        </a:lnSpc>
                      </a:pPr>
                      <a:r>
                        <a:rPr lang="en-US" sz="18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-7.699 eV (-177.54 kcal/mol) </a:t>
                      </a:r>
                      <a:endParaRPr lang="ja-JP" sz="18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sz="1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-15 </a:t>
                      </a:r>
                      <a:r>
                        <a:rPr lang="en-US" sz="18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meV</a:t>
                      </a:r>
                      <a:r>
                        <a:rPr lang="en-US" sz="1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 (-0.34 kcal/mol) </a:t>
                      </a:r>
                      <a:endParaRPr lang="ja-JP" sz="18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7151344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indent="69850" algn="r">
                        <a:lnSpc>
                          <a:spcPts val="1300"/>
                        </a:lnSpc>
                      </a:pPr>
                      <a:r>
                        <a:rPr lang="en-US" sz="1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p-Me-</a:t>
                      </a:r>
                      <a:r>
                        <a:rPr lang="en-US" sz="18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PhTeH</a:t>
                      </a:r>
                      <a:r>
                        <a:rPr lang="en-US" sz="1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 </a:t>
                      </a:r>
                      <a:endParaRPr lang="ja-JP" sz="18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indent="69850" algn="ctr">
                        <a:lnSpc>
                          <a:spcPts val="1300"/>
                        </a:lnSpc>
                      </a:pPr>
                      <a:r>
                        <a:rPr lang="en-US" sz="1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-7.738 eV (-178.44 kcal/mol) </a:t>
                      </a:r>
                      <a:endParaRPr lang="ja-JP" sz="18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sz="1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-54 </a:t>
                      </a:r>
                      <a:r>
                        <a:rPr lang="en-US" sz="18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meV</a:t>
                      </a:r>
                      <a:r>
                        <a:rPr lang="en-US" sz="1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 (-1.24 kcal/mol) </a:t>
                      </a:r>
                      <a:endParaRPr lang="ja-JP" sz="18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7960459"/>
                  </a:ext>
                </a:extLst>
              </a:tr>
            </a:tbl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74D51694-CC23-4F23-BB62-717FBFFEC5C0}"/>
              </a:ext>
            </a:extLst>
          </p:cNvPr>
          <p:cNvSpPr txBox="1"/>
          <p:nvPr/>
        </p:nvSpPr>
        <p:spPr>
          <a:xfrm>
            <a:off x="2677139" y="2541967"/>
            <a:ext cx="7268311" cy="2615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ts val="1300"/>
              </a:lnSpc>
            </a:pPr>
            <a:r>
              <a:rPr lang="en-US" altLang="ja-JP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Table S1</a:t>
            </a:r>
            <a:r>
              <a:rPr lang="en-US" altLang="ja-JP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. Substituent effect on the </a:t>
            </a:r>
            <a:r>
              <a:rPr lang="en-US" altLang="ja-JP" sz="14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Te</a:t>
            </a:r>
            <a:r>
              <a:rPr lang="en-US" altLang="ja-JP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-H bond formation energy of </a:t>
            </a:r>
            <a:r>
              <a:rPr lang="en-US" altLang="ja-JP" sz="14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PhM</a:t>
            </a:r>
            <a:r>
              <a:rPr lang="en-US" altLang="ja-JP" sz="14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−</a:t>
            </a:r>
            <a:r>
              <a:rPr lang="en-US" altLang="ja-JP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 + H</a:t>
            </a:r>
            <a:r>
              <a:rPr lang="en-US" altLang="ja-JP" sz="14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+</a:t>
            </a:r>
            <a:r>
              <a:rPr lang="en-US" altLang="ja-JP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 </a:t>
            </a:r>
            <a:r>
              <a:rPr lang="en-US" altLang="ja-JP" sz="1400" dirty="0">
                <a:solidFill>
                  <a:srgbClr val="000000"/>
                </a:solidFill>
                <a:effectLst/>
                <a:latin typeface="ＭＳ 明朝" panose="02020609040205080304" pitchFamily="17" charset="-128"/>
                <a:ea typeface="SimSun" panose="02010600030101010101" pitchFamily="2" charset="-122"/>
                <a:cs typeface="ＭＳ 明朝" panose="02020609040205080304" pitchFamily="17" charset="-128"/>
              </a:rPr>
              <a:t>→</a:t>
            </a:r>
            <a:r>
              <a:rPr lang="en-US" altLang="ja-JP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 </a:t>
            </a:r>
            <a:r>
              <a:rPr lang="en-US" altLang="ja-JP" sz="14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PhMH</a:t>
            </a:r>
            <a:endParaRPr lang="ja-JP" altLang="ja-JP" sz="14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130625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27FEC2CE-B049-4BAB-A5FB-390696E6002A}"/>
              </a:ext>
            </a:extLst>
          </p:cNvPr>
          <p:cNvSpPr txBox="1"/>
          <p:nvPr/>
        </p:nvSpPr>
        <p:spPr>
          <a:xfrm flipH="1">
            <a:off x="1530032" y="4390566"/>
            <a:ext cx="9285113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100" b="1" kern="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Figure S1.</a:t>
            </a:r>
            <a:r>
              <a:rPr lang="en-US" altLang="ja-JP" sz="1100" kern="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 Reaction energy diagram for electron transfer to (</a:t>
            </a:r>
            <a:r>
              <a:rPr lang="en-US" altLang="ja-JP" sz="1100" kern="0" dirty="0" err="1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PhM</a:t>
            </a:r>
            <a:r>
              <a:rPr lang="en-US" altLang="ja-JP" sz="1100" kern="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)</a:t>
            </a:r>
            <a:r>
              <a:rPr lang="en-US" altLang="ja-JP" sz="1100" kern="0" baseline="-2500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2</a:t>
            </a:r>
            <a:r>
              <a:rPr lang="en-US" altLang="ja-JP" sz="1100" kern="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 with the M-M distance, </a:t>
            </a:r>
            <a:r>
              <a:rPr lang="en-US" altLang="ja-JP" sz="1100" i="1" kern="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d</a:t>
            </a:r>
            <a:r>
              <a:rPr lang="en-US" altLang="ja-JP" sz="1100" kern="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, being the reaction coordinate: (a) M = S, (b) M = Se, (c) M = </a:t>
            </a:r>
            <a:r>
              <a:rPr lang="en-US" altLang="ja-JP" sz="1100" kern="0" dirty="0" err="1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Te</a:t>
            </a:r>
            <a:r>
              <a:rPr lang="en-US" altLang="ja-JP" sz="1100" kern="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. The upper branch is the neutral molecule, and the lower branch is the radical anion molecule. The stable structures of the neutral and anion molecules are located at (</a:t>
            </a:r>
            <a:r>
              <a:rPr lang="en-US" altLang="ja-JP" sz="1100" i="1" kern="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d</a:t>
            </a:r>
            <a:r>
              <a:rPr lang="en-US" altLang="ja-JP" sz="1100" kern="0" baseline="-2500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0</a:t>
            </a:r>
            <a:r>
              <a:rPr lang="en-US" altLang="ja-JP" sz="1100" kern="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, </a:t>
            </a:r>
            <a:r>
              <a:rPr lang="en-US" altLang="ja-JP" sz="1100" i="1" kern="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E</a:t>
            </a:r>
            <a:r>
              <a:rPr lang="en-US" altLang="ja-JP" sz="1100" kern="0" baseline="-2500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0</a:t>
            </a:r>
            <a:r>
              <a:rPr lang="en-US" altLang="ja-JP" sz="1100" kern="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) and (</a:t>
            </a:r>
            <a:r>
              <a:rPr lang="en-US" altLang="ja-JP" sz="1100" i="1" kern="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d</a:t>
            </a:r>
            <a:r>
              <a:rPr lang="en-US" altLang="ja-JP" sz="1100" kern="0" baseline="-2500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−</a:t>
            </a:r>
            <a:r>
              <a:rPr lang="en-US" altLang="ja-JP" sz="1100" kern="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, </a:t>
            </a:r>
            <a:r>
              <a:rPr lang="en-US" altLang="ja-JP" sz="1100" i="1" kern="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E</a:t>
            </a:r>
            <a:r>
              <a:rPr lang="en-US" altLang="ja-JP" sz="1100" kern="0" baseline="-2500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−</a:t>
            </a:r>
            <a:r>
              <a:rPr lang="en-US" altLang="ja-JP" sz="1100" kern="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), respectively. The electron transfer occurs at </a:t>
            </a:r>
            <a:r>
              <a:rPr lang="en-US" altLang="ja-JP" sz="1100" i="1" kern="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d </a:t>
            </a:r>
            <a:r>
              <a:rPr lang="en-US" altLang="ja-JP" sz="1100" kern="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= </a:t>
            </a:r>
            <a:r>
              <a:rPr lang="en-US" altLang="ja-JP" sz="1100" i="1" kern="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d</a:t>
            </a:r>
            <a:r>
              <a:rPr lang="en-US" altLang="ja-JP" sz="1100" kern="0" baseline="-2500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T</a:t>
            </a:r>
            <a:r>
              <a:rPr lang="en-US" altLang="ja-JP" sz="1100" kern="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, where energy of the molecule changes from </a:t>
            </a:r>
            <a:r>
              <a:rPr lang="en-US" altLang="ja-JP" sz="1100" i="1" kern="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E</a:t>
            </a:r>
            <a:r>
              <a:rPr lang="en-US" altLang="ja-JP" sz="1100" kern="0" baseline="-2500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T</a:t>
            </a:r>
            <a:r>
              <a:rPr lang="en-US" altLang="ja-JP" sz="1100" kern="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 to </a:t>
            </a:r>
            <a:r>
              <a:rPr lang="en-US" altLang="ja-JP" sz="1100" i="1" kern="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E</a:t>
            </a:r>
            <a:r>
              <a:rPr lang="en-US" altLang="ja-JP" sz="1100" kern="0" baseline="-2500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T</a:t>
            </a:r>
            <a:r>
              <a:rPr lang="en-US" altLang="ja-JP" sz="1100" i="1" kern="0" baseline="-2500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-</a:t>
            </a:r>
            <a:r>
              <a:rPr lang="en-US" altLang="ja-JP" sz="1100" kern="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 under the condition of </a:t>
            </a:r>
            <a:r>
              <a:rPr lang="en-US" altLang="ja-JP" sz="1100" i="1" kern="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E</a:t>
            </a:r>
            <a:r>
              <a:rPr lang="en-US" altLang="ja-JP" sz="1100" kern="0" baseline="-2500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T</a:t>
            </a:r>
            <a:r>
              <a:rPr lang="en-US" altLang="ja-JP" sz="1100" i="1" kern="0" baseline="-2500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-</a:t>
            </a:r>
            <a:r>
              <a:rPr lang="en-US" altLang="ja-JP" sz="1100" kern="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−</a:t>
            </a:r>
            <a:r>
              <a:rPr lang="en-US" altLang="ja-JP" sz="1100" i="1" kern="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E</a:t>
            </a:r>
            <a:r>
              <a:rPr lang="en-US" altLang="ja-JP" sz="1100" kern="0" baseline="-2500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T</a:t>
            </a:r>
            <a:r>
              <a:rPr lang="en-US" altLang="ja-JP" sz="1100" kern="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 = </a:t>
            </a:r>
            <a:r>
              <a:rPr lang="en-US" altLang="ja-JP" sz="1100" i="1" kern="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μ</a:t>
            </a:r>
            <a:r>
              <a:rPr lang="en-US" altLang="ja-JP" sz="1100" kern="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. The chemical potential of electron is set to </a:t>
            </a:r>
            <a:r>
              <a:rPr lang="en-US" altLang="ja-JP" sz="1100" i="1" kern="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μ </a:t>
            </a:r>
            <a:r>
              <a:rPr lang="en-US" altLang="ja-JP" sz="1100" kern="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= −2.81 eV = −64.8 kcal/mol as an example. The activation energy, ∆</a:t>
            </a:r>
            <a:r>
              <a:rPr lang="en-US" altLang="ja-JP" sz="1100" i="1" kern="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E</a:t>
            </a:r>
            <a:r>
              <a:rPr lang="en-US" altLang="ja-JP" sz="1100" kern="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, is </a:t>
            </a:r>
            <a:r>
              <a:rPr lang="en-US" altLang="ja-JP" sz="1100" i="1" kern="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E</a:t>
            </a:r>
            <a:r>
              <a:rPr lang="en-US" altLang="ja-JP" sz="1100" kern="0" baseline="-2500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T</a:t>
            </a:r>
            <a:r>
              <a:rPr lang="en-US" altLang="ja-JP" sz="1100" kern="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−</a:t>
            </a:r>
            <a:r>
              <a:rPr lang="en-US" altLang="ja-JP" sz="1100" i="1" kern="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E</a:t>
            </a:r>
            <a:r>
              <a:rPr lang="en-US" altLang="ja-JP" sz="1100" kern="0" baseline="-2500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0</a:t>
            </a:r>
            <a:r>
              <a:rPr lang="en-US" altLang="ja-JP" sz="1100" kern="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. The total energy of dissociated molecules, </a:t>
            </a:r>
            <a:r>
              <a:rPr lang="en-US" altLang="ja-JP" sz="1100" kern="0" dirty="0" err="1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PhM</a:t>
            </a:r>
            <a:r>
              <a:rPr lang="en-US" altLang="ja-JP" sz="1100" kern="0" baseline="3000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•</a:t>
            </a:r>
            <a:r>
              <a:rPr lang="en-US" altLang="ja-JP" sz="1100" kern="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 and </a:t>
            </a:r>
            <a:r>
              <a:rPr lang="en-US" altLang="ja-JP" sz="1100" kern="0" dirty="0" err="1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PhM</a:t>
            </a:r>
            <a:r>
              <a:rPr lang="en-US" altLang="ja-JP" sz="1100" kern="0" baseline="3000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−</a:t>
            </a:r>
            <a:r>
              <a:rPr lang="en-US" altLang="ja-JP" sz="1100" kern="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, is shown as </a:t>
            </a:r>
            <a:r>
              <a:rPr lang="en-US" altLang="ja-JP" sz="1100" i="1" kern="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E</a:t>
            </a:r>
            <a:r>
              <a:rPr lang="en-US" altLang="ja-JP" sz="1100" kern="0" baseline="-2500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D</a:t>
            </a:r>
            <a:r>
              <a:rPr lang="en-US" altLang="ja-JP" sz="1100" kern="0" dirty="0"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 on the right side.</a:t>
            </a:r>
            <a:endParaRPr lang="ja-JP" altLang="ja-JP" sz="11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8AD5D5B4-0EED-42EE-91A1-A744774EAA64}"/>
              </a:ext>
            </a:extLst>
          </p:cNvPr>
          <p:cNvGrpSpPr/>
          <p:nvPr/>
        </p:nvGrpSpPr>
        <p:grpSpPr>
          <a:xfrm>
            <a:off x="1291407" y="1609759"/>
            <a:ext cx="9865287" cy="2647668"/>
            <a:chOff x="834207" y="581059"/>
            <a:chExt cx="9865287" cy="2647668"/>
          </a:xfrm>
        </p:grpSpPr>
        <p:pic>
          <p:nvPicPr>
            <p:cNvPr id="8" name="図 7" descr="グラフ&#10;&#10;自動的に生成された説明">
              <a:extLst>
                <a:ext uri="{FF2B5EF4-FFF2-40B4-BE49-F238E27FC236}">
                  <a16:creationId xmlns:a16="http://schemas.microsoft.com/office/drawing/2014/main" id="{BD91E8B0-123F-44D7-A132-DCB75174F04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34207" y="869355"/>
              <a:ext cx="3419380" cy="2359372"/>
            </a:xfrm>
            <a:prstGeom prst="rect">
              <a:avLst/>
            </a:prstGeom>
          </p:spPr>
        </p:pic>
        <p:pic>
          <p:nvPicPr>
            <p:cNvPr id="9" name="図 8" descr="グラフ&#10;&#10;自動的に生成された説明">
              <a:extLst>
                <a:ext uri="{FF2B5EF4-FFF2-40B4-BE49-F238E27FC236}">
                  <a16:creationId xmlns:a16="http://schemas.microsoft.com/office/drawing/2014/main" id="{866B9007-BC16-4AC7-8507-7FE7AC2450E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57160" y="869355"/>
              <a:ext cx="3419380" cy="2355867"/>
            </a:xfrm>
            <a:prstGeom prst="rect">
              <a:avLst/>
            </a:prstGeom>
          </p:spPr>
        </p:pic>
        <p:pic>
          <p:nvPicPr>
            <p:cNvPr id="10" name="図 9" descr="グラフ&#10;&#10;自動的に生成された説明">
              <a:extLst>
                <a:ext uri="{FF2B5EF4-FFF2-40B4-BE49-F238E27FC236}">
                  <a16:creationId xmlns:a16="http://schemas.microsoft.com/office/drawing/2014/main" id="{3B19B520-75D2-408B-BF2F-DF0EE0500E7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280114" y="869355"/>
              <a:ext cx="3419380" cy="2359372"/>
            </a:xfrm>
            <a:prstGeom prst="rect">
              <a:avLst/>
            </a:prstGeom>
          </p:spPr>
        </p:pic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E5168C03-B867-468C-B296-7F5800458A8F}"/>
                </a:ext>
              </a:extLst>
            </p:cNvPr>
            <p:cNvSpPr txBox="1"/>
            <p:nvPr/>
          </p:nvSpPr>
          <p:spPr>
            <a:xfrm flipH="1">
              <a:off x="834207" y="581059"/>
              <a:ext cx="134775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kumimoji="1"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) (</a:t>
              </a:r>
              <a:r>
                <a:rPr kumimoji="1" lang="en-US" altLang="ja-JP" sz="1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hS</a:t>
              </a:r>
              <a:r>
                <a:rPr kumimoji="1"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r>
                <a:rPr kumimoji="1" lang="en-US" altLang="ja-JP" sz="16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1" lang="ja-JP" altLang="en-US" sz="1600" baseline="-25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311C898E-7446-4A4E-8064-C340B398C060}"/>
                </a:ext>
              </a:extLst>
            </p:cNvPr>
            <p:cNvSpPr txBox="1"/>
            <p:nvPr/>
          </p:nvSpPr>
          <p:spPr>
            <a:xfrm flipH="1">
              <a:off x="4057160" y="581059"/>
              <a:ext cx="134775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kumimoji="1"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b) (</a:t>
              </a:r>
              <a:r>
                <a:rPr kumimoji="1" lang="en-US" altLang="ja-JP" sz="1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hSe</a:t>
              </a:r>
              <a:r>
                <a:rPr kumimoji="1"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r>
                <a:rPr kumimoji="1" lang="en-US" altLang="ja-JP" sz="16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1" lang="ja-JP" altLang="en-US" sz="1600" baseline="-25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9240B9CB-4E4F-4CD2-B247-C2D347C3DAF9}"/>
                </a:ext>
              </a:extLst>
            </p:cNvPr>
            <p:cNvSpPr txBox="1"/>
            <p:nvPr/>
          </p:nvSpPr>
          <p:spPr>
            <a:xfrm flipH="1">
              <a:off x="7280114" y="581059"/>
              <a:ext cx="134775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kumimoji="1"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c) (</a:t>
              </a:r>
              <a:r>
                <a:rPr kumimoji="1" lang="en-US" altLang="ja-JP" sz="1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hTe</a:t>
              </a:r>
              <a:r>
                <a:rPr kumimoji="1"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r>
                <a:rPr kumimoji="1" lang="en-US" altLang="ja-JP" sz="16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1" lang="ja-JP" altLang="en-US" sz="1600" baseline="-25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2877242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1">
            <a:extLst>
              <a:ext uri="{FF2B5EF4-FFF2-40B4-BE49-F238E27FC236}">
                <a16:creationId xmlns:a16="http://schemas.microsoft.com/office/drawing/2014/main" id="{EEE05CFC-0722-4B1C-AA95-C9F75AC4A102}"/>
              </a:ext>
            </a:extLst>
          </p:cNvPr>
          <p:cNvSpPr txBox="1"/>
          <p:nvPr/>
        </p:nvSpPr>
        <p:spPr>
          <a:xfrm>
            <a:off x="2355924" y="1844840"/>
            <a:ext cx="6953539" cy="905510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>
              <a:lnSpc>
                <a:spcPts val="1300"/>
              </a:lnSpc>
            </a:pPr>
            <a:r>
              <a:rPr lang="en-US" altLang="ja-JP" sz="11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Table S2.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 </a:t>
            </a:r>
            <a:r>
              <a:rPr lang="en-US" altLang="ja-JP" sz="11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d</a:t>
            </a:r>
            <a:r>
              <a:rPr lang="en-US" altLang="ja-JP" sz="1100" baseline="-25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0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: M-M bond length, </a:t>
            </a:r>
            <a:r>
              <a:rPr lang="en-US" altLang="ja-JP" sz="11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E</a:t>
            </a:r>
            <a:r>
              <a:rPr lang="en-US" altLang="ja-JP" sz="1100" baseline="-25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0− 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= </a:t>
            </a:r>
            <a:r>
              <a:rPr lang="en-US" altLang="ja-JP" sz="11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E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(</a:t>
            </a:r>
            <a:r>
              <a:rPr lang="en-US" altLang="ja-JP" sz="11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d</a:t>
            </a:r>
            <a:r>
              <a:rPr lang="en-US" altLang="ja-JP" sz="1100" baseline="-25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0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, [(</a:t>
            </a:r>
            <a:r>
              <a:rPr lang="en-US" altLang="ja-JP" sz="11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PhM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)</a:t>
            </a:r>
            <a:r>
              <a:rPr lang="en-US" altLang="ja-JP" sz="1100" baseline="-25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2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]</a:t>
            </a:r>
            <a:r>
              <a:rPr lang="en-US" altLang="ja-JP" sz="11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•−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): energy of the anion molecule at </a:t>
            </a:r>
            <a:r>
              <a:rPr lang="en-US" altLang="ja-JP" sz="11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d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 = </a:t>
            </a:r>
            <a:r>
              <a:rPr lang="en-US" altLang="ja-JP" sz="11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d</a:t>
            </a:r>
            <a:r>
              <a:rPr lang="en-US" altLang="ja-JP" sz="1100" baseline="-25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0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, </a:t>
            </a:r>
            <a:r>
              <a:rPr lang="en-US" altLang="ja-JP" sz="11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d</a:t>
            </a:r>
            <a:r>
              <a:rPr lang="en-US" altLang="ja-JP" sz="1100" baseline="-25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T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: M-M distance in the transition state, ∆</a:t>
            </a:r>
            <a:r>
              <a:rPr lang="en-US" altLang="ja-JP" sz="11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E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: activation energy for electron transfer. Here, the chemical potential is assumed to be −2.81 eV = −64.8 kcal/mol to evaluate </a:t>
            </a:r>
            <a:r>
              <a:rPr lang="en-US" altLang="ja-JP" sz="11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d</a:t>
            </a:r>
            <a:r>
              <a:rPr lang="en-US" altLang="ja-JP" sz="1100" baseline="-25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T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 and ∆</a:t>
            </a:r>
            <a:r>
              <a:rPr lang="en-US" altLang="ja-JP" sz="11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E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. </a:t>
            </a:r>
            <a:endParaRPr lang="ja-JP" altLang="ja-JP" sz="11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ts val="1300"/>
              </a:lnSpc>
            </a:pPr>
            <a:endParaRPr lang="ja-JP" sz="8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graphicFrame>
        <p:nvGraphicFramePr>
          <p:cNvPr id="12" name="表 12">
            <a:extLst>
              <a:ext uri="{FF2B5EF4-FFF2-40B4-BE49-F238E27FC236}">
                <a16:creationId xmlns:a16="http://schemas.microsoft.com/office/drawing/2014/main" id="{EBDB5B10-6BD1-4710-B1A6-10E7D0EA0935}"/>
              </a:ext>
            </a:extLst>
          </p:cNvPr>
          <p:cNvGraphicFramePr>
            <a:graphicFrameLocks noGrp="1"/>
          </p:cNvGraphicFramePr>
          <p:nvPr/>
        </p:nvGraphicFramePr>
        <p:xfrm>
          <a:off x="2376245" y="2483920"/>
          <a:ext cx="6966267" cy="14833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68630">
                  <a:extLst>
                    <a:ext uri="{9D8B030D-6E8A-4147-A177-3AD203B41FA5}">
                      <a16:colId xmlns:a16="http://schemas.microsoft.com/office/drawing/2014/main" val="3910873278"/>
                    </a:ext>
                  </a:extLst>
                </a:gridCol>
                <a:gridCol w="754380">
                  <a:extLst>
                    <a:ext uri="{9D8B030D-6E8A-4147-A177-3AD203B41FA5}">
                      <a16:colId xmlns:a16="http://schemas.microsoft.com/office/drawing/2014/main" val="1491842950"/>
                    </a:ext>
                  </a:extLst>
                </a:gridCol>
                <a:gridCol w="2590482">
                  <a:extLst>
                    <a:ext uri="{9D8B030D-6E8A-4147-A177-3AD203B41FA5}">
                      <a16:colId xmlns:a16="http://schemas.microsoft.com/office/drawing/2014/main" val="2349963874"/>
                    </a:ext>
                  </a:extLst>
                </a:gridCol>
                <a:gridCol w="682943">
                  <a:extLst>
                    <a:ext uri="{9D8B030D-6E8A-4147-A177-3AD203B41FA5}">
                      <a16:colId xmlns:a16="http://schemas.microsoft.com/office/drawing/2014/main" val="380030898"/>
                    </a:ext>
                  </a:extLst>
                </a:gridCol>
                <a:gridCol w="2469832">
                  <a:extLst>
                    <a:ext uri="{9D8B030D-6E8A-4147-A177-3AD203B41FA5}">
                      <a16:colId xmlns:a16="http://schemas.microsoft.com/office/drawing/2014/main" val="3253207670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</a:t>
                      </a:r>
                      <a:endParaRPr kumimoji="1" lang="ja-JP" altLang="en-US" sz="18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i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</a:t>
                      </a:r>
                      <a:r>
                        <a:rPr kumimoji="1" lang="en-US" altLang="ja-JP" sz="1800" b="0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r>
                        <a:rPr kumimoji="1" lang="en-US" altLang="ja-JP" sz="1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Å]</a:t>
                      </a:r>
                      <a:endParaRPr kumimoji="1" lang="ja-JP" altLang="en-US" sz="1800" b="0" baseline="-25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</a:t>
                      </a:r>
                      <a:r>
                        <a:rPr kumimoji="1" lang="en-US" altLang="ja-JP" sz="1800" b="0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-</a:t>
                      </a:r>
                      <a:endParaRPr kumimoji="1" lang="ja-JP" altLang="en-US" sz="1800" b="0" baseline="-25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</a:t>
                      </a:r>
                      <a:r>
                        <a:rPr kumimoji="1" lang="en-US" altLang="ja-JP" sz="1800" b="0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</a:t>
                      </a:r>
                      <a:r>
                        <a:rPr kumimoji="1" lang="en-US" altLang="ja-JP" sz="1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</a:t>
                      </a:r>
                      <a:r>
                        <a:rPr kumimoji="1" lang="en-US" altLang="ja-JP" sz="1800" b="0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</a:t>
                      </a:r>
                      <a:r>
                        <a:rPr kumimoji="1" lang="en-US" altLang="ja-JP" sz="1800" b="0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1800" b="0" baseline="-25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Δ</a:t>
                      </a:r>
                      <a:r>
                        <a:rPr kumimoji="1" lang="en-US" altLang="ja-JP" sz="1800" b="0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</a:t>
                      </a:r>
                      <a:endParaRPr kumimoji="1" lang="ja-JP" altLang="en-US" sz="1800" b="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7477941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kumimoji="1" lang="ja-JP" altLang="en-US" sz="18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86</a:t>
                      </a:r>
                      <a:endParaRPr kumimoji="1" lang="ja-JP" altLang="en-US" sz="18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-1.912eV (-44.1kcal/mol) </a:t>
                      </a:r>
                      <a:endParaRPr lang="ja-JP" sz="1800" b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3</a:t>
                      </a:r>
                      <a:endParaRPr kumimoji="1" lang="ja-JP" altLang="en-US" sz="18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indent="69850" algn="ctr">
                        <a:lnSpc>
                          <a:spcPts val="1300"/>
                        </a:lnSpc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0.300eV (6.9kcal/mol) </a:t>
                      </a:r>
                      <a:endParaRPr lang="ja-JP" sz="1800" b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8447347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</a:t>
                      </a:r>
                      <a:endParaRPr kumimoji="1" lang="ja-JP" altLang="en-US" sz="18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88</a:t>
                      </a:r>
                      <a:endParaRPr kumimoji="1" lang="ja-JP" altLang="en-US" sz="18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-2.235eV (-51.5kcal/mol) </a:t>
                      </a:r>
                      <a:endParaRPr lang="ja-JP" sz="1800" b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9</a:t>
                      </a:r>
                      <a:endParaRPr kumimoji="1" lang="ja-JP" altLang="en-US" sz="18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indent="69850" algn="ctr">
                        <a:lnSpc>
                          <a:spcPts val="1300"/>
                        </a:lnSpc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0.139eV (3.2kcal/mol) </a:t>
                      </a:r>
                      <a:endParaRPr lang="ja-JP" sz="1800" b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3282066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e</a:t>
                      </a:r>
                      <a:endParaRPr kumimoji="1" lang="ja-JP" altLang="en-US" sz="18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733</a:t>
                      </a:r>
                      <a:endParaRPr kumimoji="1" lang="ja-JP" altLang="en-US" sz="18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-2.361eV (-54.5kcal/mol) </a:t>
                      </a:r>
                      <a:endParaRPr lang="ja-JP" sz="1800" b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8</a:t>
                      </a:r>
                      <a:endParaRPr kumimoji="1" lang="ja-JP" altLang="en-US" sz="18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indent="69850" algn="ctr">
                        <a:lnSpc>
                          <a:spcPts val="1300"/>
                        </a:lnSpc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0.126eV (2.9kcal/mol) </a:t>
                      </a:r>
                      <a:endParaRPr lang="ja-JP" sz="1800" b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6807703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473208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 descr="グラフ, 折れ線グラフ&#10;&#10;自動的に生成された説明">
            <a:extLst>
              <a:ext uri="{FF2B5EF4-FFF2-40B4-BE49-F238E27FC236}">
                <a16:creationId xmlns:a16="http://schemas.microsoft.com/office/drawing/2014/main" id="{114EDAB2-C2AC-40F0-8B77-96ECCFE5E85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80710" y="1333713"/>
            <a:ext cx="4837228" cy="3359471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19123247-1E34-47B8-B65F-7455E568EA0C}"/>
              </a:ext>
            </a:extLst>
          </p:cNvPr>
          <p:cNvSpPr txBox="1"/>
          <p:nvPr/>
        </p:nvSpPr>
        <p:spPr>
          <a:xfrm flipH="1">
            <a:off x="3421959" y="4716616"/>
            <a:ext cx="4768538" cy="4257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ts val="1300"/>
              </a:lnSpc>
            </a:pPr>
            <a:r>
              <a:rPr lang="en-US" altLang="ja-JP" sz="12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Figure S2.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 Activation energy for electron transfer, ∆</a:t>
            </a:r>
            <a:r>
              <a:rPr lang="en-US" altLang="ja-JP" sz="12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E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, as a function of the chemical potential of the electron, </a:t>
            </a:r>
            <a:r>
              <a:rPr lang="en-US" altLang="ja-JP" sz="12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μ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, in (</a:t>
            </a:r>
            <a:r>
              <a:rPr lang="en-US" altLang="ja-JP" sz="12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PhM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)</a:t>
            </a:r>
            <a:r>
              <a:rPr lang="en-US" altLang="ja-JP" sz="1200" baseline="-25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2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 (M = S, Se, </a:t>
            </a:r>
            <a:r>
              <a:rPr lang="en-US" altLang="ja-JP" sz="12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Te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). </a:t>
            </a:r>
            <a:endParaRPr lang="ja-JP" altLang="ja-JP" sz="12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569273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466</Words>
  <Application>Microsoft Office PowerPoint</Application>
  <PresentationFormat>ワイド画面</PresentationFormat>
  <Paragraphs>42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11" baseType="lpstr">
      <vt:lpstr>ＭＳ 明朝</vt:lpstr>
      <vt:lpstr>游ゴシック</vt:lpstr>
      <vt:lpstr>游ゴシック Light</vt:lpstr>
      <vt:lpstr>Arial</vt:lpstr>
      <vt:lpstr>Palatino Linotype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ato Hara</dc:creator>
  <cp:lastModifiedBy>Takato Hara</cp:lastModifiedBy>
  <cp:revision>1</cp:revision>
  <dcterms:created xsi:type="dcterms:W3CDTF">2021-08-28T01:35:30Z</dcterms:created>
  <dcterms:modified xsi:type="dcterms:W3CDTF">2021-08-28T01:43:58Z</dcterms:modified>
</cp:coreProperties>
</file>